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78"/>
    <p:restoredTop sz="94694"/>
  </p:normalViewPr>
  <p:slideViewPr>
    <p:cSldViewPr snapToGrid="0" showGuides="1">
      <p:cViewPr>
        <p:scale>
          <a:sx n="217" d="100"/>
          <a:sy n="217" d="100"/>
        </p:scale>
        <p:origin x="776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760603-7B14-AB44-9DE1-E2EF40323409}" type="datetimeFigureOut">
              <a:t>2024/4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4390D-E830-D04E-8250-9146598888EA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5045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4258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565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913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198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41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51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511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944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85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853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5674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EA59E-DC36-0347-9CEE-8C2889022D03}" type="datetimeFigureOut"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0FAFC-5C93-364A-9CBE-1955ACA8DA5D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24751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DDFB423-DCA2-9E0B-3F08-1D5BE906C83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88863" y="895335"/>
            <a:ext cx="3556962" cy="354683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C3FE2FA-A7F8-AA66-6FA2-2DA3E8B2DEE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43903" y="7105910"/>
            <a:ext cx="570983" cy="1099866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A652DA5-BCBF-B842-E0D0-0512D326A4A1}"/>
              </a:ext>
            </a:extLst>
          </p:cNvPr>
          <p:cNvSpPr txBox="1"/>
          <p:nvPr/>
        </p:nvSpPr>
        <p:spPr>
          <a:xfrm>
            <a:off x="1386029" y="8464100"/>
            <a:ext cx="458910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D-Genies-generated dot-plots among 1,083 unanchored contigs (a) and those with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bulbocastan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(b). These unanchored contigs shared similarities with the terminal regions of specific </a:t>
            </a:r>
            <a:r>
              <a:rPr kumimoji="1" lang="en-US" altLang="ja-JP" sz="1000" i="1">
                <a:latin typeface="Times New Roman" panose="02020603050405020304" pitchFamily="18" charset="0"/>
                <a:cs typeface="Times New Roman" panose="02020603050405020304" pitchFamily="18" charset="0"/>
              </a:rPr>
              <a:t>S. bulbocastanum </a:t>
            </a:r>
            <a:r>
              <a:rPr kumimoji="1"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. </a:t>
            </a:r>
            <a:endParaRPr kumimoji="1"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2D2DC335-EB2C-04FF-546F-E4B6055500F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688864" y="4804553"/>
            <a:ext cx="3556961" cy="3466377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8019195-E86B-D14F-A449-0048047493BD}"/>
              </a:ext>
            </a:extLst>
          </p:cNvPr>
          <p:cNvSpPr txBox="1"/>
          <p:nvPr/>
        </p:nvSpPr>
        <p:spPr>
          <a:xfrm>
            <a:off x="2806745" y="4633324"/>
            <a:ext cx="13211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>
                <a:latin typeface="Helvetica" pitchFamily="2" charset="0"/>
              </a:rPr>
              <a:t>Solanum bulbocastanum</a:t>
            </a:r>
            <a:endParaRPr kumimoji="1" lang="ja-JP" altLang="en-US" sz="800" i="1">
              <a:latin typeface="Helvetica" pitchFamily="2" charset="0"/>
            </a:endParaRPr>
          </a:p>
        </p:txBody>
      </p:sp>
      <p:sp>
        <p:nvSpPr>
          <p:cNvPr id="6" name="テキスト ボックス 27">
            <a:extLst>
              <a:ext uri="{FF2B5EF4-FFF2-40B4-BE49-F238E27FC236}">
                <a16:creationId xmlns:a16="http://schemas.microsoft.com/office/drawing/2014/main" id="{E7FC9CE2-541F-E779-EE43-B4E0384996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4598" y="4669473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9" name="テキスト ボックス 26">
            <a:extLst>
              <a:ext uri="{FF2B5EF4-FFF2-40B4-BE49-F238E27FC236}">
                <a16:creationId xmlns:a16="http://schemas.microsoft.com/office/drawing/2014/main" id="{36ABDBA9-A5E9-E7F0-6820-3DC09EC0DD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24598" y="863600"/>
            <a:ext cx="3397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kumimoji="1" lang="en-US" altLang="ja-JP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5218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</TotalTime>
  <Words>42</Words>
  <Application>Microsoft Macintosh PowerPoint</Application>
  <PresentationFormat>A4 210 x 297 mm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aka</dc:creator>
  <cp:lastModifiedBy>*</cp:lastModifiedBy>
  <cp:revision>12</cp:revision>
  <dcterms:created xsi:type="dcterms:W3CDTF">2023-11-03T07:37:49Z</dcterms:created>
  <dcterms:modified xsi:type="dcterms:W3CDTF">2024-04-19T22:55:25Z</dcterms:modified>
</cp:coreProperties>
</file>